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-642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343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934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034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7049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932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069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489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105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386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1968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148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487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3995677"/>
            <a:ext cx="2566136" cy="2862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. S2. </a:t>
            </a:r>
            <a:r>
              <a:rPr lang="en-US" dirty="0"/>
              <a:t>Greenhouse experiment to phenotype tolerance of soybean to the infection of the soybean cyst nematode based on plant biomass. There were 480 16-cm-diam pots for 60 soybean lines each time of the experiment. </a:t>
            </a:r>
            <a:r>
              <a:rPr lang="en-US" dirty="0" smtClean="0"/>
              <a:t> </a:t>
            </a:r>
            <a:endParaRPr lang="en-US" dirty="0"/>
          </a:p>
        </p:txBody>
      </p:sp>
      <p:pic>
        <p:nvPicPr>
          <p:cNvPr id="2" name="Picture 1" descr="DSCN0210.jp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4745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</TotalTime>
  <Words>39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cond Ravelombola</dc:creator>
  <cp:lastModifiedBy>Jayaseela</cp:lastModifiedBy>
  <cp:revision>12</cp:revision>
  <dcterms:created xsi:type="dcterms:W3CDTF">2020-02-04T23:30:38Z</dcterms:created>
  <dcterms:modified xsi:type="dcterms:W3CDTF">2020-06-25T14:48:08Z</dcterms:modified>
</cp:coreProperties>
</file>